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7" r:id="rId2"/>
    <p:sldId id="259" r:id="rId3"/>
    <p:sldId id="261" r:id="rId4"/>
    <p:sldId id="262" r:id="rId5"/>
    <p:sldId id="274" r:id="rId6"/>
    <p:sldId id="266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1280" y="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9E4E75-3ABC-48B3-9B6B-AA01AFE4A261}" type="datetimeFigureOut">
              <a:rPr lang="zh-CN" altLang="en-US" smtClean="0"/>
              <a:t>2021/6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02E906-ECF5-46C6-BDEF-B38215A38F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05028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C509-8A43-4D3A-AF56-7518AC4AB3E2}" type="datetimeFigureOut">
              <a:rPr lang="zh-CN" altLang="en-US" smtClean="0"/>
              <a:t>2021/6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CC4D-A746-47B5-BE94-0B930C8166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93561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C509-8A43-4D3A-AF56-7518AC4AB3E2}" type="datetimeFigureOut">
              <a:rPr lang="zh-CN" altLang="en-US" smtClean="0"/>
              <a:t>2021/6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CC4D-A746-47B5-BE94-0B930C8166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6222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C509-8A43-4D3A-AF56-7518AC4AB3E2}" type="datetimeFigureOut">
              <a:rPr lang="zh-CN" altLang="en-US" smtClean="0"/>
              <a:t>2021/6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CC4D-A746-47B5-BE94-0B930C8166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32910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C509-8A43-4D3A-AF56-7518AC4AB3E2}" type="datetimeFigureOut">
              <a:rPr lang="zh-CN" altLang="en-US" smtClean="0"/>
              <a:t>2021/6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CC4D-A746-47B5-BE94-0B930C8166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5506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C509-8A43-4D3A-AF56-7518AC4AB3E2}" type="datetimeFigureOut">
              <a:rPr lang="zh-CN" altLang="en-US" smtClean="0"/>
              <a:t>2021/6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CC4D-A746-47B5-BE94-0B930C8166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4399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C509-8A43-4D3A-AF56-7518AC4AB3E2}" type="datetimeFigureOut">
              <a:rPr lang="zh-CN" altLang="en-US" smtClean="0"/>
              <a:t>2021/6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CC4D-A746-47B5-BE94-0B930C8166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2228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C509-8A43-4D3A-AF56-7518AC4AB3E2}" type="datetimeFigureOut">
              <a:rPr lang="zh-CN" altLang="en-US" smtClean="0"/>
              <a:t>2021/6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CC4D-A746-47B5-BE94-0B930C8166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7942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C509-8A43-4D3A-AF56-7518AC4AB3E2}" type="datetimeFigureOut">
              <a:rPr lang="zh-CN" altLang="en-US" smtClean="0"/>
              <a:t>2021/6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CC4D-A746-47B5-BE94-0B930C8166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7185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C509-8A43-4D3A-AF56-7518AC4AB3E2}" type="datetimeFigureOut">
              <a:rPr lang="zh-CN" altLang="en-US" smtClean="0"/>
              <a:t>2021/6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CC4D-A746-47B5-BE94-0B930C8166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0124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C509-8A43-4D3A-AF56-7518AC4AB3E2}" type="datetimeFigureOut">
              <a:rPr lang="zh-CN" altLang="en-US" smtClean="0"/>
              <a:t>2021/6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CC4D-A746-47B5-BE94-0B930C8166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93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2C509-8A43-4D3A-AF56-7518AC4AB3E2}" type="datetimeFigureOut">
              <a:rPr lang="zh-CN" altLang="en-US" smtClean="0"/>
              <a:t>2021/6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CC4D-A746-47B5-BE94-0B930C8166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598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2C509-8A43-4D3A-AF56-7518AC4AB3E2}" type="datetimeFigureOut">
              <a:rPr lang="zh-CN" altLang="en-US" smtClean="0"/>
              <a:t>2021/6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63CC4D-A746-47B5-BE94-0B930C8166C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46666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 descr="C:\Users\Bangzhou\Desktop\研究项目\阑尾术\OTU\Diveristy.16s.p.tif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72360" y="228600"/>
            <a:ext cx="2926080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372360" y="1981200"/>
            <a:ext cx="4389120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372360" y="3776673"/>
            <a:ext cx="3657600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304800" y="343689"/>
            <a:ext cx="9060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smtClean="0"/>
              <a:t>Fig S1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329622" y="129846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smtClean="0"/>
              <a:t>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329622" y="1882447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/>
              <a:t>B</a:t>
            </a:r>
            <a:endParaRPr lang="en-US" altLang="zh-CN" sz="2400" smtClean="0"/>
          </a:p>
        </p:txBody>
      </p:sp>
      <p:sp>
        <p:nvSpPr>
          <p:cNvPr id="13" name="TextBox 12"/>
          <p:cNvSpPr txBox="1"/>
          <p:nvPr/>
        </p:nvSpPr>
        <p:spPr>
          <a:xfrm>
            <a:off x="2329622" y="3657600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smtClean="0"/>
              <a:t>C</a:t>
            </a:r>
          </a:p>
        </p:txBody>
      </p:sp>
      <p:sp>
        <p:nvSpPr>
          <p:cNvPr id="14" name="矩形 13"/>
          <p:cNvSpPr/>
          <p:nvPr/>
        </p:nvSpPr>
        <p:spPr>
          <a:xfrm>
            <a:off x="152400" y="5456872"/>
            <a:ext cx="891540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terations of gut bacterial diversity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exes,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on 16S V4 sequencing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. (A)  Comparisons between healthy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jects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appendectomy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w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pendectomy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wo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 (B) Comparisons among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w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horter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an 2 years (</a:t>
            </a:r>
            <a:r>
              <a:rPr lang="zh-CN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＜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Y), longer than or equal to 2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ars but shorter than 5years  (2-5Y), longer than 5 years (</a:t>
            </a:r>
            <a:r>
              <a:rPr lang="zh-CN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≥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Y), and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wo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(C)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s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w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horter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an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rs (</a:t>
            </a:r>
            <a:r>
              <a:rPr lang="zh-CN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＜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Y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longer than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rs (</a:t>
            </a:r>
            <a:r>
              <a:rPr lang="zh-CN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5Y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and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wo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27175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2" descr="C:\Users\Bangzhou\Desktop\阑尾术\taxa\16S\Phylum.diff.tif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177"/>
          <a:stretch/>
        </p:blipFill>
        <p:spPr bwMode="auto">
          <a:xfrm>
            <a:off x="152400" y="996389"/>
            <a:ext cx="3924729" cy="32867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11" descr="C:\Users\Bangzhou\Desktop\阑尾术\taxa\16S\Family.diff.tif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6200" y="1006549"/>
            <a:ext cx="5186111" cy="35654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04800" y="343689"/>
            <a:ext cx="9060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smtClean="0"/>
              <a:t>Fig S2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-28900" y="821072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smtClean="0"/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901440" y="821071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/>
              <a:t>B</a:t>
            </a:r>
            <a:endParaRPr lang="en-US" altLang="zh-CN" sz="2400" smtClean="0"/>
          </a:p>
        </p:txBody>
      </p:sp>
      <p:sp>
        <p:nvSpPr>
          <p:cNvPr id="7" name="矩形 6"/>
          <p:cNvSpPr/>
          <p:nvPr/>
        </p:nvSpPr>
        <p:spPr>
          <a:xfrm>
            <a:off x="0" y="4724400"/>
            <a:ext cx="89154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abundances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gut bacterial taxa in phylum (A) and family (B) levels significantly different (P&lt;0.05) between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lthy subjects with appendectomy (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w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with appendectomy (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wo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27175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Bangzhou\Desktop\阑尾术\taxa\16S\Genus.diff.tif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805354"/>
            <a:ext cx="9144001" cy="5029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04800" y="343689"/>
            <a:ext cx="9060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smtClean="0"/>
              <a:t>Fig S3</a:t>
            </a:r>
          </a:p>
        </p:txBody>
      </p:sp>
      <p:sp>
        <p:nvSpPr>
          <p:cNvPr id="4" name="矩形 3"/>
          <p:cNvSpPr/>
          <p:nvPr/>
        </p:nvSpPr>
        <p:spPr>
          <a:xfrm>
            <a:off x="114299" y="5834554"/>
            <a:ext cx="8915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abundances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gut bacterial genera significantly different (P&lt;0.05) between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lthy subjects with appendectomy (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w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with appendectomy (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wo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87608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Bangzhou\Desktop\研究项目\阑尾术\OTU\Diveristy.ITS.p.tif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5161" y="152400"/>
            <a:ext cx="2926080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325161" y="1981200"/>
            <a:ext cx="3657600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325161" y="3804920"/>
            <a:ext cx="4389120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304800" y="343689"/>
            <a:ext cx="9060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smtClean="0"/>
              <a:t>Fig S4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346960" y="71734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smtClean="0"/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346960" y="1900535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/>
              <a:t>B</a:t>
            </a:r>
            <a:endParaRPr lang="en-US" altLang="zh-CN" sz="2400" smtClean="0"/>
          </a:p>
        </p:txBody>
      </p:sp>
      <p:sp>
        <p:nvSpPr>
          <p:cNvPr id="9" name="TextBox 8"/>
          <p:cNvSpPr txBox="1"/>
          <p:nvPr/>
        </p:nvSpPr>
        <p:spPr>
          <a:xfrm>
            <a:off x="2346960" y="3729335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smtClean="0"/>
              <a:t>C</a:t>
            </a:r>
          </a:p>
        </p:txBody>
      </p:sp>
      <p:sp>
        <p:nvSpPr>
          <p:cNvPr id="10" name="矩形 9"/>
          <p:cNvSpPr/>
          <p:nvPr/>
        </p:nvSpPr>
        <p:spPr>
          <a:xfrm>
            <a:off x="152400" y="5456872"/>
            <a:ext cx="891540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terations of gut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ngal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versity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exes,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on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TS2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ing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. (A)  Comparisons between healthy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jects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appendectomy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w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pendectomy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wo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 (B)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s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w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orter than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rs (</a:t>
            </a:r>
            <a:r>
              <a:rPr lang="zh-CN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＜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Y), longer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an and equal to 2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rs (</a:t>
            </a:r>
            <a:r>
              <a:rPr lang="zh-CN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≥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Y) and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wo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(C)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s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ong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w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horter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an 2 years (</a:t>
            </a:r>
            <a:r>
              <a:rPr lang="zh-CN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＜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Y), longer than or equal to 2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ars but shorter than 5years  (2-5Y), longer than 5 years (</a:t>
            </a:r>
            <a:r>
              <a:rPr lang="zh-CN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≥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Y), and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Wo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87608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6" descr="C:\Users\Bangzhou\Desktop\阑尾术\taxa\ITS\rdp0.5-410\Phylum.diff.tif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1295400"/>
            <a:ext cx="3638223" cy="36382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304800" y="343689"/>
            <a:ext cx="9060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smtClean="0"/>
              <a:t>Fig S5</a:t>
            </a:r>
          </a:p>
        </p:txBody>
      </p:sp>
      <p:pic>
        <p:nvPicPr>
          <p:cNvPr id="16" name="Picture 3" descr="C:\Users\Bangzhou\Desktop\阑尾术\taxa\ITS\rdp0.5-410\Family.diff.abu05.tif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4199" y="1295400"/>
            <a:ext cx="5698573" cy="39177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323200" y="1214735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smtClean="0"/>
              <a:t>A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948510" y="1214735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/>
              <a:t>B</a:t>
            </a:r>
            <a:endParaRPr lang="en-US" altLang="zh-CN" sz="2400" smtClean="0"/>
          </a:p>
        </p:txBody>
      </p:sp>
      <p:sp>
        <p:nvSpPr>
          <p:cNvPr id="19" name="矩形 18"/>
          <p:cNvSpPr/>
          <p:nvPr/>
        </p:nvSpPr>
        <p:spPr>
          <a:xfrm>
            <a:off x="0" y="5248870"/>
            <a:ext cx="89154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abundances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gut fungal taxa in phylum (A) and family (B) levels significantly different (P&lt;0.05) between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lthy subjects with appendectomy (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w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with appendectomy (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wo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17143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:\Users\Bangzhou\Desktop\阑尾术\taxa\ITS\rdp0.5-410\Genus.diff.abu05.tif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200" y="762000"/>
            <a:ext cx="7315200" cy="5029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04800" y="343689"/>
            <a:ext cx="9060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smtClean="0"/>
              <a:t>Fig S6</a:t>
            </a:r>
          </a:p>
        </p:txBody>
      </p:sp>
      <p:sp>
        <p:nvSpPr>
          <p:cNvPr id="6" name="矩形 5"/>
          <p:cNvSpPr/>
          <p:nvPr/>
        </p:nvSpPr>
        <p:spPr>
          <a:xfrm>
            <a:off x="114299" y="5834554"/>
            <a:ext cx="8915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abundances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gut fungal genera significantly different (P&lt;0.05) between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lthy subjects with appendectomy (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w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with appendectomy (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wo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58277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7</TotalTime>
  <Words>348</Words>
  <Application>Microsoft Office PowerPoint</Application>
  <PresentationFormat>全屏显示(4:3)</PresentationFormat>
  <Paragraphs>22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宋体</vt:lpstr>
      <vt:lpstr>Arial</vt:lpstr>
      <vt:lpstr>Calibri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Bangzhou</dc:creator>
  <cp:lastModifiedBy>Choi sky</cp:lastModifiedBy>
  <cp:revision>22</cp:revision>
  <dcterms:created xsi:type="dcterms:W3CDTF">2020-02-20T03:44:17Z</dcterms:created>
  <dcterms:modified xsi:type="dcterms:W3CDTF">2021-06-14T13:45:04Z</dcterms:modified>
</cp:coreProperties>
</file>